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5BE263C-DBD7-4A20-BB59-AAB30ACAA65A}" styleName="Mittlere Formatvorlage 3 - Akz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4" d="100"/>
          <a:sy n="114" d="100"/>
        </p:scale>
        <p:origin x="1440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F1C8FE8-995E-4B11-82E2-DC02CD597BAD}" type="datetimeFigureOut">
              <a:rPr lang="de-DE" smtClean="0"/>
              <a:t>18.11.2021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A43A215-9C07-4715-8F33-320564B9DBBF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350266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828AD-E5D6-4228-9F1B-7AD29A9F699F}" type="datetimeFigureOut">
              <a:rPr lang="de-DE" smtClean="0"/>
              <a:t>18.1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63D86-AAE6-4A97-8C71-D514C92053D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356417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828AD-E5D6-4228-9F1B-7AD29A9F699F}" type="datetimeFigureOut">
              <a:rPr lang="de-DE" smtClean="0"/>
              <a:t>18.1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63D86-AAE6-4A97-8C71-D514C92053D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444396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828AD-E5D6-4228-9F1B-7AD29A9F699F}" type="datetimeFigureOut">
              <a:rPr lang="de-DE" smtClean="0"/>
              <a:t>18.1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63D86-AAE6-4A97-8C71-D514C92053D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28229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828AD-E5D6-4228-9F1B-7AD29A9F699F}" type="datetimeFigureOut">
              <a:rPr lang="de-DE" smtClean="0"/>
              <a:t>18.1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63D86-AAE6-4A97-8C71-D514C92053D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286738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828AD-E5D6-4228-9F1B-7AD29A9F699F}" type="datetimeFigureOut">
              <a:rPr lang="de-DE" smtClean="0"/>
              <a:t>18.1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63D86-AAE6-4A97-8C71-D514C92053D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970175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828AD-E5D6-4228-9F1B-7AD29A9F699F}" type="datetimeFigureOut">
              <a:rPr lang="de-DE" smtClean="0"/>
              <a:t>18.11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63D86-AAE6-4A97-8C71-D514C92053D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04662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828AD-E5D6-4228-9F1B-7AD29A9F699F}" type="datetimeFigureOut">
              <a:rPr lang="de-DE" smtClean="0"/>
              <a:t>18.11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63D86-AAE6-4A97-8C71-D514C92053D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7673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828AD-E5D6-4228-9F1B-7AD29A9F699F}" type="datetimeFigureOut">
              <a:rPr lang="de-DE" smtClean="0"/>
              <a:t>18.11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63D86-AAE6-4A97-8C71-D514C92053D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39634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828AD-E5D6-4228-9F1B-7AD29A9F699F}" type="datetimeFigureOut">
              <a:rPr lang="de-DE" smtClean="0"/>
              <a:t>18.11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63D86-AAE6-4A97-8C71-D514C92053D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916598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828AD-E5D6-4228-9F1B-7AD29A9F699F}" type="datetimeFigureOut">
              <a:rPr lang="de-DE" smtClean="0"/>
              <a:t>18.11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63D86-AAE6-4A97-8C71-D514C92053D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854566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828AD-E5D6-4228-9F1B-7AD29A9F699F}" type="datetimeFigureOut">
              <a:rPr lang="de-DE" smtClean="0"/>
              <a:t>18.11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63D86-AAE6-4A97-8C71-D514C92053D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723423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4828AD-E5D6-4228-9F1B-7AD29A9F699F}" type="datetimeFigureOut">
              <a:rPr lang="de-DE" smtClean="0"/>
              <a:t>18.11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963D86-AAE6-4A97-8C71-D514C92053D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214838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/>
          <p:cNvSpPr txBox="1"/>
          <p:nvPr/>
        </p:nvSpPr>
        <p:spPr>
          <a:xfrm>
            <a:off x="1333948" y="2516484"/>
            <a:ext cx="13195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Cf-</a:t>
            </a:r>
            <a:r>
              <a:rPr lang="de-D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miRNA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ng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ul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7" name="Textfeld 6"/>
          <p:cNvSpPr txBox="1"/>
          <p:nvPr/>
        </p:nvSpPr>
        <p:spPr>
          <a:xfrm rot="16200000">
            <a:off x="35116" y="1485166"/>
            <a:ext cx="69442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Density</a:t>
            </a:r>
            <a:endParaRPr lang="de-DE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hteck 7"/>
          <p:cNvSpPr/>
          <p:nvPr/>
        </p:nvSpPr>
        <p:spPr>
          <a:xfrm>
            <a:off x="251520" y="476673"/>
            <a:ext cx="590465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1: Distribution of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f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-miRNA at baseline (n=250)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31"/>
          <a:stretch/>
        </p:blipFill>
        <p:spPr bwMode="auto">
          <a:xfrm>
            <a:off x="531773" y="980728"/>
            <a:ext cx="2907770" cy="15357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460984" y="2893072"/>
            <a:ext cx="43851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A density plot shows the distribution of cf-miRNA across the cohort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9914845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84878972"/>
              </p:ext>
            </p:extLst>
          </p:nvPr>
        </p:nvGraphicFramePr>
        <p:xfrm>
          <a:off x="1043608" y="1772816"/>
          <a:ext cx="7023098" cy="1362075"/>
        </p:xfrm>
        <a:graphic>
          <a:graphicData uri="http://schemas.openxmlformats.org/drawingml/2006/table">
            <a:tbl>
              <a:tblPr/>
              <a:tblGrid>
                <a:gridCol w="1162004">
                  <a:extLst>
                    <a:ext uri="{9D8B030D-6E8A-4147-A177-3AD203B41FA5}">
                      <a16:colId xmlns:a16="http://schemas.microsoft.com/office/drawing/2014/main" val="3977258589"/>
                    </a:ext>
                  </a:extLst>
                </a:gridCol>
                <a:gridCol w="976849">
                  <a:extLst>
                    <a:ext uri="{9D8B030D-6E8A-4147-A177-3AD203B41FA5}">
                      <a16:colId xmlns:a16="http://schemas.microsoft.com/office/drawing/2014/main" val="3722751964"/>
                    </a:ext>
                  </a:extLst>
                </a:gridCol>
                <a:gridCol w="976849">
                  <a:extLst>
                    <a:ext uri="{9D8B030D-6E8A-4147-A177-3AD203B41FA5}">
                      <a16:colId xmlns:a16="http://schemas.microsoft.com/office/drawing/2014/main" val="181088464"/>
                    </a:ext>
                  </a:extLst>
                </a:gridCol>
                <a:gridCol w="976849">
                  <a:extLst>
                    <a:ext uri="{9D8B030D-6E8A-4147-A177-3AD203B41FA5}">
                      <a16:colId xmlns:a16="http://schemas.microsoft.com/office/drawing/2014/main" val="2692234862"/>
                    </a:ext>
                  </a:extLst>
                </a:gridCol>
                <a:gridCol w="976849">
                  <a:extLst>
                    <a:ext uri="{9D8B030D-6E8A-4147-A177-3AD203B41FA5}">
                      <a16:colId xmlns:a16="http://schemas.microsoft.com/office/drawing/2014/main" val="3183829170"/>
                    </a:ext>
                  </a:extLst>
                </a:gridCol>
                <a:gridCol w="976849">
                  <a:extLst>
                    <a:ext uri="{9D8B030D-6E8A-4147-A177-3AD203B41FA5}">
                      <a16:colId xmlns:a16="http://schemas.microsoft.com/office/drawing/2014/main" val="2707978577"/>
                    </a:ext>
                  </a:extLst>
                </a:gridCol>
                <a:gridCol w="976849">
                  <a:extLst>
                    <a:ext uri="{9D8B030D-6E8A-4147-A177-3AD203B41FA5}">
                      <a16:colId xmlns:a16="http://schemas.microsoft.com/office/drawing/2014/main" val="1098806006"/>
                    </a:ext>
                  </a:extLst>
                </a:gridCol>
              </a:tblGrid>
              <a:tr h="200025">
                <a:tc>
                  <a:txBody>
                    <a:bodyPr/>
                    <a:lstStyle/>
                    <a:p>
                      <a:pPr algn="l" fontAlgn="b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VERALL SURVIVAL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ROGRESSION-FREE SURVIVAL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00150977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333399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variate HR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33333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5% CI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33333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33333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33333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ultivariate HR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 w="6350" cap="flat" cmpd="sng" algn="ctr">
                      <a:solidFill>
                        <a:srgbClr val="33333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5% CI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33333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33333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-value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33333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2356134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ge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2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9 - 1.05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166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1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9 - 1.04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904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094744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ubtype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58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18 - 2.11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19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16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94 - 1.44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1711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07893588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age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28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56 - 3.33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14E-05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20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.35 - 4.36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37E-13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968048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Grade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18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5 - 2.54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730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07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1 - 1.89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108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1806688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l" fontAlgn="t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f-miRNA median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.85</a:t>
                      </a:r>
                    </a:p>
                  </a:txBody>
                  <a:tcPr marL="9525" marR="9525" marT="9525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26 - 11.82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183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.14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92 - 8.93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t"/>
                      <a:r>
                        <a:rPr lang="en-US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003</a:t>
                      </a:r>
                    </a:p>
                  </a:txBody>
                  <a:tcPr marL="9525" marR="9525" marT="9525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45912779"/>
                  </a:ext>
                </a:extLst>
              </a:tr>
            </a:tbl>
          </a:graphicData>
        </a:graphic>
      </p:graphicFrame>
      <p:sp>
        <p:nvSpPr>
          <p:cNvPr id="4" name="Rechteck 7"/>
          <p:cNvSpPr/>
          <p:nvPr/>
        </p:nvSpPr>
        <p:spPr>
          <a:xfrm>
            <a:off x="827584" y="764704"/>
            <a:ext cx="5904656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ble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1: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ultivariate analysis using </a:t>
            </a:r>
            <a:r>
              <a:rPr lang="en-US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f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miRNA median levels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3979001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4</TotalTime>
  <Words>111</Words>
  <Application>Microsoft Office PowerPoint</Application>
  <PresentationFormat>On-screen Show (4:3)</PresentationFormat>
  <Paragraphs>4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Larissa</vt:lpstr>
      <vt:lpstr>PowerPoint Presentation</vt:lpstr>
      <vt:lpstr>PowerPoint Presentation</vt:lpstr>
    </vt:vector>
  </TitlesOfParts>
  <Company>Universitätsklinikum Heidelbe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Gahlawat, Aoife</dc:creator>
  <cp:lastModifiedBy>Gahlawat, Aoife</cp:lastModifiedBy>
  <cp:revision>252</cp:revision>
  <dcterms:created xsi:type="dcterms:W3CDTF">2019-08-01T09:47:36Z</dcterms:created>
  <dcterms:modified xsi:type="dcterms:W3CDTF">2021-11-18T14:30:55Z</dcterms:modified>
</cp:coreProperties>
</file>